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61" r:id="rId4"/>
    <p:sldId id="258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4" d="100"/>
          <a:sy n="74" d="100"/>
        </p:scale>
        <p:origin x="-204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973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21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29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154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675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111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000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325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532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27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305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B6235-AC28-5C4A-86A4-4EB90A58D2B2}" type="datetimeFigureOut">
              <a:rPr lang="en-US" smtClean="0"/>
              <a:t>10/0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EEDAD-FF54-7142-B2AC-60213FD61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687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1138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. Fig.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03999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rcRect t="1084" b="1084"/>
          <a:stretch>
            <a:fillRect/>
          </a:stretch>
        </p:blipFill>
        <p:spPr>
          <a:xfrm>
            <a:off x="12671" y="1355726"/>
            <a:ext cx="9174024" cy="5045360"/>
          </a:xfrm>
        </p:spPr>
      </p:pic>
      <p:sp>
        <p:nvSpPr>
          <p:cNvPr id="5" name="TextBox 4"/>
          <p:cNvSpPr txBox="1"/>
          <p:nvPr/>
        </p:nvSpPr>
        <p:spPr>
          <a:xfrm>
            <a:off x="343275" y="1355726"/>
            <a:ext cx="2798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. Fig. 2, curved phanto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6864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rcRect t="-27978" b="-27978"/>
          <a:stretch>
            <a:fillRect/>
          </a:stretch>
        </p:blipFill>
        <p:spPr>
          <a:xfrm>
            <a:off x="0" y="646331"/>
            <a:ext cx="9176784" cy="5497339"/>
          </a:xfrm>
        </p:spPr>
      </p:pic>
      <p:sp>
        <p:nvSpPr>
          <p:cNvPr id="5" name="TextBox 4"/>
          <p:cNvSpPr txBox="1"/>
          <p:nvPr/>
        </p:nvSpPr>
        <p:spPr>
          <a:xfrm>
            <a:off x="0" y="0"/>
            <a:ext cx="71806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. Fig. 3 oil capsule positioning for patient imaging. A) for lower arm AVFs</a:t>
            </a:r>
            <a:r>
              <a:rPr lang="en-US" dirty="0"/>
              <a:t>;</a:t>
            </a:r>
            <a:r>
              <a:rPr lang="en-US" dirty="0" smtClean="0"/>
              <a:t> B) for lower arm AVF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16883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73100"/>
            <a:ext cx="9144000" cy="550228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161"/>
            <a:ext cx="3421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. Fig. </a:t>
            </a:r>
            <a:r>
              <a:rPr lang="en-US" dirty="0" smtClean="0"/>
              <a:t>4 Phantom </a:t>
            </a:r>
            <a:r>
              <a:rPr lang="en-US" dirty="0" smtClean="0"/>
              <a:t>MRI exampl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79875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rcRect l="702" r="702"/>
          <a:stretch>
            <a:fillRect/>
          </a:stretch>
        </p:blipFill>
        <p:spPr>
          <a:xfrm>
            <a:off x="0" y="386492"/>
            <a:ext cx="9188956" cy="6323493"/>
          </a:xfrm>
        </p:spPr>
      </p:pic>
      <p:sp>
        <p:nvSpPr>
          <p:cNvPr id="5" name="TextBox 4"/>
          <p:cNvSpPr txBox="1"/>
          <p:nvPr/>
        </p:nvSpPr>
        <p:spPr>
          <a:xfrm>
            <a:off x="0" y="17161"/>
            <a:ext cx="3294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. Fig. 5 Patient MRI exampl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7266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4</Words>
  <Application>Microsoft Macintosh PowerPoint</Application>
  <PresentationFormat>On-screen Show (4:3)</PresentationFormat>
  <Paragraphs>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or MacDonald</dc:creator>
  <cp:lastModifiedBy>Conor MacDonald</cp:lastModifiedBy>
  <cp:revision>2</cp:revision>
  <dcterms:created xsi:type="dcterms:W3CDTF">2020-04-10T08:16:38Z</dcterms:created>
  <dcterms:modified xsi:type="dcterms:W3CDTF">2020-04-10T08:22:37Z</dcterms:modified>
</cp:coreProperties>
</file>